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92" r:id="rId2"/>
    <p:sldId id="293" r:id="rId3"/>
    <p:sldId id="294" r:id="rId4"/>
    <p:sldId id="295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2670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9496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2592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7078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9491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516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057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969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3417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7065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989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82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9F9F4-519F-46BB-B3F1-541F5F16FA24}" type="datetimeFigureOut">
              <a:rPr lang="en-GB" smtClean="0"/>
              <a:t>24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87610-5DE0-49CC-9B69-81A1CE26C1C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925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A35FACA-7238-4F69-8817-A1E6FFEFFC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8375611"/>
              </p:ext>
            </p:extLst>
          </p:nvPr>
        </p:nvGraphicFramePr>
        <p:xfrm>
          <a:off x="480855" y="606424"/>
          <a:ext cx="5568287" cy="11585576"/>
        </p:xfrm>
        <a:graphic>
          <a:graphicData uri="http://schemas.openxmlformats.org/drawingml/2006/table">
            <a:tbl>
              <a:tblPr>
                <a:tableStyleId>{BDBED569-4797-4DF1-A0F4-6AAB3CD982D8}</a:tableStyleId>
              </a:tblPr>
              <a:tblGrid>
                <a:gridCol w="963755">
                  <a:extLst>
                    <a:ext uri="{9D8B030D-6E8A-4147-A177-3AD203B41FA5}">
                      <a16:colId xmlns:a16="http://schemas.microsoft.com/office/drawing/2014/main" val="1339728124"/>
                    </a:ext>
                  </a:extLst>
                </a:gridCol>
                <a:gridCol w="901220">
                  <a:extLst>
                    <a:ext uri="{9D8B030D-6E8A-4147-A177-3AD203B41FA5}">
                      <a16:colId xmlns:a16="http://schemas.microsoft.com/office/drawing/2014/main" val="654989743"/>
                    </a:ext>
                  </a:extLst>
                </a:gridCol>
                <a:gridCol w="639422">
                  <a:extLst>
                    <a:ext uri="{9D8B030D-6E8A-4147-A177-3AD203B41FA5}">
                      <a16:colId xmlns:a16="http://schemas.microsoft.com/office/drawing/2014/main" val="2550314574"/>
                    </a:ext>
                  </a:extLst>
                </a:gridCol>
                <a:gridCol w="799275">
                  <a:extLst>
                    <a:ext uri="{9D8B030D-6E8A-4147-A177-3AD203B41FA5}">
                      <a16:colId xmlns:a16="http://schemas.microsoft.com/office/drawing/2014/main" val="2922347987"/>
                    </a:ext>
                  </a:extLst>
                </a:gridCol>
                <a:gridCol w="559493">
                  <a:extLst>
                    <a:ext uri="{9D8B030D-6E8A-4147-A177-3AD203B41FA5}">
                      <a16:colId xmlns:a16="http://schemas.microsoft.com/office/drawing/2014/main" val="1573670109"/>
                    </a:ext>
                  </a:extLst>
                </a:gridCol>
                <a:gridCol w="1065700">
                  <a:extLst>
                    <a:ext uri="{9D8B030D-6E8A-4147-A177-3AD203B41FA5}">
                      <a16:colId xmlns:a16="http://schemas.microsoft.com/office/drawing/2014/main" val="4119074671"/>
                    </a:ext>
                  </a:extLst>
                </a:gridCol>
                <a:gridCol w="639422">
                  <a:extLst>
                    <a:ext uri="{9D8B030D-6E8A-4147-A177-3AD203B41FA5}">
                      <a16:colId xmlns:a16="http://schemas.microsoft.com/office/drawing/2014/main" val="3860862106"/>
                    </a:ext>
                  </a:extLst>
                </a:gridCol>
              </a:tblGrid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 MiRNA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TRAIL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Curcumin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TRAIL+Curcumin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87307328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 ID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Fold Change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p-value 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Fold Change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p-value 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Fold Change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p-value 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2482069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hsa-let-7a-5p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9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25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8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0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9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41215670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  <a:latin typeface="+mn-lt"/>
                        </a:rPr>
                        <a:t>hsa-let-7c-5p</a:t>
                      </a:r>
                      <a:endParaRPr lang="en-GB" sz="800" b="1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effectLst/>
                          <a:latin typeface="+mn-lt"/>
                        </a:rPr>
                        <a:t>3.52</a:t>
                      </a:r>
                      <a:endParaRPr lang="en-GB" sz="800" b="1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effectLst/>
                          <a:latin typeface="+mn-lt"/>
                        </a:rPr>
                        <a:t>0.18</a:t>
                      </a:r>
                      <a:endParaRPr lang="en-GB" sz="800" b="1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effectLst/>
                          <a:latin typeface="+mn-lt"/>
                        </a:rPr>
                        <a:t>3.14</a:t>
                      </a:r>
                      <a:endParaRPr lang="en-GB" sz="800" b="1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>
                          <a:effectLst/>
                          <a:latin typeface="+mn-lt"/>
                        </a:rPr>
                        <a:t>0.001</a:t>
                      </a:r>
                      <a:endParaRPr lang="en-GB" sz="800" b="1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  <a:latin typeface="+mn-lt"/>
                        </a:rPr>
                        <a:t>4.06</a:t>
                      </a:r>
                      <a:endParaRPr lang="en-GB" sz="800" b="1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GB" sz="800" b="1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5144639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hsa-let-7e-5p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7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3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62197177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let-7g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58681781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9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49828173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01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73698073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06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0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41461497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22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5378546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25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08406928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25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3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71117938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28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0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0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4365114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285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22735952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33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5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1112561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33b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60450413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34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33991457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1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21145464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3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3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14443530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4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27001576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5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26695213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6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9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7078316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49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972950617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53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8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3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0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41689718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5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24598594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5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14475615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6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66575682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7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86696771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1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42130777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1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31039701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1c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67662606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1d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0166835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3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4614508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5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61173939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86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41699838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92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3915539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93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2047596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93b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88046035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94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5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97026044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195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63407857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0c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1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5414036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3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0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18527120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4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0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20822918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5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5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426489257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05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46549099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0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9405784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1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1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33390733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10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3.4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3.5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71949699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12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21713532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14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3.0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03254641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18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66913421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21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5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70344719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22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80463304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3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0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90273391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4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54277232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5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7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59278902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6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0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50001975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6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9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81463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7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0316768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9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21636871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9b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3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65638368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29c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3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5156896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0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20765547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0b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4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0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88319497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0c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845513951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0d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3.3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3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4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79691309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0e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36916084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1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7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2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1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4051459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2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9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263447255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38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8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57476766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4a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7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522734957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4c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4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92746681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65b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5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6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20841128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378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8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93234304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409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7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25435025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449a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8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237484033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451a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08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8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2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36181917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491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81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9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57690574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497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7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041936350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512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4217450529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542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0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4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08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746066606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7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2.0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5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1899058104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708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49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6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2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2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6803130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9-5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7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4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6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19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51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432646462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hsa-miR-92a-3p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2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7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0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7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0.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3139163693"/>
                  </a:ext>
                </a:extLst>
              </a:tr>
              <a:tr h="134716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hsa-miR-98-5p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1.66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34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5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03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>
                          <a:effectLst/>
                          <a:latin typeface="+mn-lt"/>
                        </a:rPr>
                        <a:t>1.73</a:t>
                      </a:r>
                      <a:endParaRPr lang="en-GB" sz="800" b="0" i="0" u="none" strike="noStrike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  <a:latin typeface="+mn-lt"/>
                        </a:rPr>
                        <a:t>0.12</a:t>
                      </a:r>
                      <a:endParaRPr lang="en-GB" sz="800" b="0" i="0" u="none" strike="noStrike" dirty="0">
                        <a:effectLst/>
                        <a:latin typeface="+mn-lt"/>
                      </a:endParaRPr>
                    </a:p>
                  </a:txBody>
                  <a:tcPr marL="5291" marR="5291" marT="5291" marB="0" anchor="b"/>
                </a:tc>
                <a:extLst>
                  <a:ext uri="{0D108BD9-81ED-4DB2-BD59-A6C34878D82A}">
                    <a16:rowId xmlns:a16="http://schemas.microsoft.com/office/drawing/2014/main" val="730179082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1" y="-94500"/>
            <a:ext cx="6857999" cy="5878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S1. Differentially deregulated apoptosis-regulating microRNAs following treatment of ACHN cells with TRAIL,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rcumin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r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urcumin+TRAIL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for 24h</a:t>
            </a:r>
            <a:endParaRPr lang="en-IE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3053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1" y="-31756"/>
            <a:ext cx="6857999" cy="3921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1. Data gating of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itoTracker</a:t>
            </a:r>
            <a:endParaRPr lang="en-IE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561" y="799860"/>
            <a:ext cx="6895679" cy="3878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6890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84871" y="-105764"/>
            <a:ext cx="6773129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S2. Optimization of let-7C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tagomir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transfection </a:t>
            </a:r>
            <a:endParaRPr kumimoji="0" lang="en-US" i="0" u="none" strike="noStrike" cap="none" normalizeH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charset="-128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866" y="6040463"/>
            <a:ext cx="3647729" cy="3200400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818865" y="1330715"/>
            <a:ext cx="3647729" cy="3200400"/>
            <a:chOff x="818866" y="1968389"/>
            <a:chExt cx="3647729" cy="3200400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8866" y="1968389"/>
              <a:ext cx="3647729" cy="320040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1651203" y="1968389"/>
              <a:ext cx="9915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24h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1542918" y="6040463"/>
            <a:ext cx="9915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48h</a:t>
            </a:r>
          </a:p>
        </p:txBody>
      </p:sp>
      <p:sp>
        <p:nvSpPr>
          <p:cNvPr id="9" name="Rectangle 8"/>
          <p:cNvSpPr/>
          <p:nvPr/>
        </p:nvSpPr>
        <p:spPr>
          <a:xfrm>
            <a:off x="308154" y="9594193"/>
            <a:ext cx="6155998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optimization of the transfection efficiency with let-7C inhibitor using </a:t>
            </a:r>
            <a:r>
              <a:rPr lang="en-US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HN </a:t>
            </a:r>
            <a:r>
              <a:rPr lang="en-IE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cultured in 24-well tissue culture plate at a cell density of 2.5 x 10</a:t>
            </a:r>
            <a:r>
              <a:rPr lang="en-IE" altLang="en-US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IE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/well. At 70% confluence, the cells were transiently transfected with let-7C inhibitor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50, 100, 200)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E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4 h and 48 using </a:t>
            </a:r>
            <a:r>
              <a:rPr lang="en-IE" alt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harmafect</a:t>
            </a:r>
            <a:r>
              <a:rPr lang="en-IE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transfection reagent in accordance with the manufacturer’s protocol. Mock transfection (MT) was performed in the absence of let-7C inhibitor. A non-targetin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crambled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RIDIA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irpin inhibitor </a:t>
            </a:r>
            <a:r>
              <a:rPr lang="en-IE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ied by the same manufacturer was used as a negative control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was used to examine the efficiency of the transfection with different concentrations of let-7C inhibitor for the indicated time points. Data are expressed as mean ± S.E.M of three independent experiments. ***P&lt; 0.001.</a:t>
            </a:r>
          </a:p>
        </p:txBody>
      </p:sp>
    </p:spTree>
    <p:extLst>
      <p:ext uri="{BB962C8B-B14F-4D97-AF65-F5344CB8AC3E}">
        <p14:creationId xmlns:p14="http://schemas.microsoft.com/office/powerpoint/2010/main" val="21877403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3458211"/>
              </p:ext>
            </p:extLst>
          </p:nvPr>
        </p:nvGraphicFramePr>
        <p:xfrm>
          <a:off x="197168" y="2837772"/>
          <a:ext cx="6423088" cy="5336965"/>
        </p:xfrm>
        <a:graphic>
          <a:graphicData uri="http://schemas.openxmlformats.org/drawingml/2006/table">
            <a:tbl>
              <a:tblPr>
                <a:tableStyleId>{BC89EF96-8CEA-46FF-86C4-4CE0E7609802}</a:tableStyleId>
              </a:tblPr>
              <a:tblGrid>
                <a:gridCol w="12246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738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00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9345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86416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Mature ID</a:t>
                      </a:r>
                      <a:endParaRPr lang="en-I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Fold changes (95% CI)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p-value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Common predicted target pathways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892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hsa-let-7c-5p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3.15 (1.96, 4.34 )</a:t>
                      </a:r>
                      <a:endParaRPr lang="en-I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0.001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FR" sz="1100">
                          <a:effectLst/>
                        </a:rPr>
                        <a:t>Cell cycle, metabolism and </a:t>
                      </a:r>
                      <a:r>
                        <a:rPr lang="en-GB" sz="1100">
                          <a:effectLst/>
                        </a:rPr>
                        <a:t>hypermethylation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4987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hsa-miR-153-3p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2.89 (1.86, 3.92)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0.0008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Transcellular transport, cell cycle and differentiation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3464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hsa-miR-30b-5p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2.02 (1.85, 2.19)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0.00005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Energy metabolism, angiogenesis and cell adhesion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8355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hsa-miR-30d-5p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3.14 (2.33, 3.96)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0.001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Cellular metabolism, angiogenesis, and cell adhesion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83552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hsa-miR-31-5p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2.15 (1.04, 3.26)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</a:rPr>
                        <a:t>0.05</a:t>
                      </a:r>
                      <a:endParaRPr lang="en-IE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</a:rPr>
                        <a:t>Hypoxia, skeletal muscle differentiation, cell death and inflammation</a:t>
                      </a:r>
                      <a:endParaRPr lang="en-IE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80" marR="6680" marT="668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0" y="146304"/>
            <a:ext cx="6898576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Table S2 .</a:t>
            </a:r>
            <a:r>
              <a:rPr kumimoji="0" lang="en-US" sz="14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Top five differentially dysregulated apoptosis-regulating microRNAs with the computational putative target pathways following curcumin treatment of ACHN cells for 24 hours</a:t>
            </a:r>
            <a:endParaRPr kumimoji="0" lang="en-IE" sz="1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E" sz="1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987624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8</TotalTime>
  <Words>910</Words>
  <Application>Microsoft Office PowerPoint</Application>
  <PresentationFormat>Widescreen</PresentationFormat>
  <Paragraphs>63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ＭＳ Ｐゴシック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mael Obaidi</dc:creator>
  <cp:lastModifiedBy>MDPI</cp:lastModifiedBy>
  <cp:revision>25</cp:revision>
  <dcterms:created xsi:type="dcterms:W3CDTF">2021-12-23T15:29:26Z</dcterms:created>
  <dcterms:modified xsi:type="dcterms:W3CDTF">2022-08-24T07:14:29Z</dcterms:modified>
</cp:coreProperties>
</file>